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31" d="100"/>
          <a:sy n="131" d="100"/>
        </p:scale>
        <p:origin x="352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00741C-EDDB-4F4C-B64E-BF2ACB15407F}" type="datetimeFigureOut">
              <a:rPr lang="en-US" smtClean="0"/>
              <a:t>1/1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BE35C9-DDC3-4021-B1E0-D926BF3C16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99599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00741C-EDDB-4F4C-B64E-BF2ACB15407F}" type="datetimeFigureOut">
              <a:rPr lang="en-US" smtClean="0"/>
              <a:t>1/1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BE35C9-DDC3-4021-B1E0-D926BF3C16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65358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00741C-EDDB-4F4C-B64E-BF2ACB15407F}" type="datetimeFigureOut">
              <a:rPr lang="en-US" smtClean="0"/>
              <a:t>1/1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BE35C9-DDC3-4021-B1E0-D926BF3C16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02609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00741C-EDDB-4F4C-B64E-BF2ACB15407F}" type="datetimeFigureOut">
              <a:rPr lang="en-US" smtClean="0"/>
              <a:t>1/1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BE35C9-DDC3-4021-B1E0-D926BF3C16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61833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00741C-EDDB-4F4C-B64E-BF2ACB15407F}" type="datetimeFigureOut">
              <a:rPr lang="en-US" smtClean="0"/>
              <a:t>1/1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BE35C9-DDC3-4021-B1E0-D926BF3C16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30139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00741C-EDDB-4F4C-B64E-BF2ACB15407F}" type="datetimeFigureOut">
              <a:rPr lang="en-US" smtClean="0"/>
              <a:t>1/17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BE35C9-DDC3-4021-B1E0-D926BF3C16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16426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00741C-EDDB-4F4C-B64E-BF2ACB15407F}" type="datetimeFigureOut">
              <a:rPr lang="en-US" smtClean="0"/>
              <a:t>1/17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BE35C9-DDC3-4021-B1E0-D926BF3C16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62047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00741C-EDDB-4F4C-B64E-BF2ACB15407F}" type="datetimeFigureOut">
              <a:rPr lang="en-US" smtClean="0"/>
              <a:t>1/17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BE35C9-DDC3-4021-B1E0-D926BF3C16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04476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00741C-EDDB-4F4C-B64E-BF2ACB15407F}" type="datetimeFigureOut">
              <a:rPr lang="en-US" smtClean="0"/>
              <a:t>1/17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BE35C9-DDC3-4021-B1E0-D926BF3C16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74624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00741C-EDDB-4F4C-B64E-BF2ACB15407F}" type="datetimeFigureOut">
              <a:rPr lang="en-US" smtClean="0"/>
              <a:t>1/17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BE35C9-DDC3-4021-B1E0-D926BF3C16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88081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00741C-EDDB-4F4C-B64E-BF2ACB15407F}" type="datetimeFigureOut">
              <a:rPr lang="en-US" smtClean="0"/>
              <a:t>1/17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BE35C9-DDC3-4021-B1E0-D926BF3C16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09669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00741C-EDDB-4F4C-B64E-BF2ACB15407F}" type="datetimeFigureOut">
              <a:rPr lang="en-US" smtClean="0"/>
              <a:t>1/1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BE35C9-DDC3-4021-B1E0-D926BF3C16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37904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Content Placeholder 4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4041371549"/>
              </p:ext>
            </p:extLst>
          </p:nvPr>
        </p:nvGraphicFramePr>
        <p:xfrm>
          <a:off x="1468672" y="2736476"/>
          <a:ext cx="1661988" cy="1683385"/>
        </p:xfrm>
        <a:graphic>
          <a:graphicData uri="http://schemas.openxmlformats.org/drawingml/2006/table">
            <a:tbl>
              <a:tblPr firstRow="1" firstCol="1" bandRow="1"/>
              <a:tblGrid>
                <a:gridCol w="585883">
                  <a:extLst>
                    <a:ext uri="{9D8B030D-6E8A-4147-A177-3AD203B41FA5}">
                      <a16:colId xmlns:a16="http://schemas.microsoft.com/office/drawing/2014/main" val="3520571107"/>
                    </a:ext>
                  </a:extLst>
                </a:gridCol>
                <a:gridCol w="522109">
                  <a:extLst>
                    <a:ext uri="{9D8B030D-6E8A-4147-A177-3AD203B41FA5}">
                      <a16:colId xmlns:a16="http://schemas.microsoft.com/office/drawing/2014/main" val="1159002876"/>
                    </a:ext>
                  </a:extLst>
                </a:gridCol>
                <a:gridCol w="553996">
                  <a:extLst>
                    <a:ext uri="{9D8B030D-6E8A-4147-A177-3AD203B41FA5}">
                      <a16:colId xmlns:a16="http://schemas.microsoft.com/office/drawing/2014/main" val="2215405953"/>
                    </a:ext>
                  </a:extLst>
                </a:gridCol>
              </a:tblGrid>
              <a:tr h="21717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time [min]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qualane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Olive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17230842"/>
                  </a:ext>
                </a:extLst>
              </a:tr>
              <a:tr h="20637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1D58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1D58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24331260"/>
                  </a:ext>
                </a:extLst>
              </a:tr>
              <a:tr h="21018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5C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1D58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70960119"/>
                  </a:ext>
                </a:extLst>
              </a:tr>
              <a:tr h="21018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5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B8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73349894"/>
                  </a:ext>
                </a:extLst>
              </a:tr>
              <a:tr h="21336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0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5C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93185102"/>
                  </a:ext>
                </a:extLst>
              </a:tr>
              <a:tr h="21336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60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31217396"/>
                  </a:ext>
                </a:extLst>
              </a:tr>
              <a:tr h="20637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80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33703311"/>
                  </a:ext>
                </a:extLst>
              </a:tr>
              <a:tr h="20637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440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10380409"/>
                  </a:ext>
                </a:extLst>
              </a:tr>
            </a:tbl>
          </a:graphicData>
        </a:graphic>
      </p:graphicFrame>
      <p:graphicFrame>
        <p:nvGraphicFramePr>
          <p:cNvPr id="7" name="Table 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34024571"/>
              </p:ext>
            </p:extLst>
          </p:nvPr>
        </p:nvGraphicFramePr>
        <p:xfrm>
          <a:off x="3340590" y="1812939"/>
          <a:ext cx="6657975" cy="2124075"/>
        </p:xfrm>
        <a:graphic>
          <a:graphicData uri="http://schemas.openxmlformats.org/drawingml/2006/table">
            <a:tbl>
              <a:tblPr firstRow="1" firstCol="1" bandRow="1"/>
              <a:tblGrid>
                <a:gridCol w="400137">
                  <a:extLst>
                    <a:ext uri="{9D8B030D-6E8A-4147-A177-3AD203B41FA5}">
                      <a16:colId xmlns:a16="http://schemas.microsoft.com/office/drawing/2014/main" val="3691811779"/>
                    </a:ext>
                  </a:extLst>
                </a:gridCol>
                <a:gridCol w="356783">
                  <a:extLst>
                    <a:ext uri="{9D8B030D-6E8A-4147-A177-3AD203B41FA5}">
                      <a16:colId xmlns:a16="http://schemas.microsoft.com/office/drawing/2014/main" val="3321087881"/>
                    </a:ext>
                  </a:extLst>
                </a:gridCol>
                <a:gridCol w="327660">
                  <a:extLst>
                    <a:ext uri="{9D8B030D-6E8A-4147-A177-3AD203B41FA5}">
                      <a16:colId xmlns:a16="http://schemas.microsoft.com/office/drawing/2014/main" val="4163064258"/>
                    </a:ext>
                  </a:extLst>
                </a:gridCol>
                <a:gridCol w="327660">
                  <a:extLst>
                    <a:ext uri="{9D8B030D-6E8A-4147-A177-3AD203B41FA5}">
                      <a16:colId xmlns:a16="http://schemas.microsoft.com/office/drawing/2014/main" val="2848547761"/>
                    </a:ext>
                  </a:extLst>
                </a:gridCol>
                <a:gridCol w="327660">
                  <a:extLst>
                    <a:ext uri="{9D8B030D-6E8A-4147-A177-3AD203B41FA5}">
                      <a16:colId xmlns:a16="http://schemas.microsoft.com/office/drawing/2014/main" val="1793363374"/>
                    </a:ext>
                  </a:extLst>
                </a:gridCol>
                <a:gridCol w="328295">
                  <a:extLst>
                    <a:ext uri="{9D8B030D-6E8A-4147-A177-3AD203B41FA5}">
                      <a16:colId xmlns:a16="http://schemas.microsoft.com/office/drawing/2014/main" val="2414123566"/>
                    </a:ext>
                  </a:extLst>
                </a:gridCol>
                <a:gridCol w="327660">
                  <a:extLst>
                    <a:ext uri="{9D8B030D-6E8A-4147-A177-3AD203B41FA5}">
                      <a16:colId xmlns:a16="http://schemas.microsoft.com/office/drawing/2014/main" val="1874842229"/>
                    </a:ext>
                  </a:extLst>
                </a:gridCol>
                <a:gridCol w="327660">
                  <a:extLst>
                    <a:ext uri="{9D8B030D-6E8A-4147-A177-3AD203B41FA5}">
                      <a16:colId xmlns:a16="http://schemas.microsoft.com/office/drawing/2014/main" val="1532285869"/>
                    </a:ext>
                  </a:extLst>
                </a:gridCol>
                <a:gridCol w="327660">
                  <a:extLst>
                    <a:ext uri="{9D8B030D-6E8A-4147-A177-3AD203B41FA5}">
                      <a16:colId xmlns:a16="http://schemas.microsoft.com/office/drawing/2014/main" val="316722960"/>
                    </a:ext>
                  </a:extLst>
                </a:gridCol>
                <a:gridCol w="328295">
                  <a:extLst>
                    <a:ext uri="{9D8B030D-6E8A-4147-A177-3AD203B41FA5}">
                      <a16:colId xmlns:a16="http://schemas.microsoft.com/office/drawing/2014/main" val="10552934"/>
                    </a:ext>
                  </a:extLst>
                </a:gridCol>
                <a:gridCol w="327660">
                  <a:extLst>
                    <a:ext uri="{9D8B030D-6E8A-4147-A177-3AD203B41FA5}">
                      <a16:colId xmlns:a16="http://schemas.microsoft.com/office/drawing/2014/main" val="2697443437"/>
                    </a:ext>
                  </a:extLst>
                </a:gridCol>
                <a:gridCol w="327660">
                  <a:extLst>
                    <a:ext uri="{9D8B030D-6E8A-4147-A177-3AD203B41FA5}">
                      <a16:colId xmlns:a16="http://schemas.microsoft.com/office/drawing/2014/main" val="4146484657"/>
                    </a:ext>
                  </a:extLst>
                </a:gridCol>
                <a:gridCol w="328295">
                  <a:extLst>
                    <a:ext uri="{9D8B030D-6E8A-4147-A177-3AD203B41FA5}">
                      <a16:colId xmlns:a16="http://schemas.microsoft.com/office/drawing/2014/main" val="1445868865"/>
                    </a:ext>
                  </a:extLst>
                </a:gridCol>
                <a:gridCol w="327660">
                  <a:extLst>
                    <a:ext uri="{9D8B030D-6E8A-4147-A177-3AD203B41FA5}">
                      <a16:colId xmlns:a16="http://schemas.microsoft.com/office/drawing/2014/main" val="40831469"/>
                    </a:ext>
                  </a:extLst>
                </a:gridCol>
                <a:gridCol w="327660">
                  <a:extLst>
                    <a:ext uri="{9D8B030D-6E8A-4147-A177-3AD203B41FA5}">
                      <a16:colId xmlns:a16="http://schemas.microsoft.com/office/drawing/2014/main" val="3419244095"/>
                    </a:ext>
                  </a:extLst>
                </a:gridCol>
                <a:gridCol w="327660">
                  <a:extLst>
                    <a:ext uri="{9D8B030D-6E8A-4147-A177-3AD203B41FA5}">
                      <a16:colId xmlns:a16="http://schemas.microsoft.com/office/drawing/2014/main" val="2975359951"/>
                    </a:ext>
                  </a:extLst>
                </a:gridCol>
                <a:gridCol w="328295">
                  <a:extLst>
                    <a:ext uri="{9D8B030D-6E8A-4147-A177-3AD203B41FA5}">
                      <a16:colId xmlns:a16="http://schemas.microsoft.com/office/drawing/2014/main" val="3111118515"/>
                    </a:ext>
                  </a:extLst>
                </a:gridCol>
                <a:gridCol w="327660">
                  <a:extLst>
                    <a:ext uri="{9D8B030D-6E8A-4147-A177-3AD203B41FA5}">
                      <a16:colId xmlns:a16="http://schemas.microsoft.com/office/drawing/2014/main" val="2578975513"/>
                    </a:ext>
                  </a:extLst>
                </a:gridCol>
                <a:gridCol w="327660">
                  <a:extLst>
                    <a:ext uri="{9D8B030D-6E8A-4147-A177-3AD203B41FA5}">
                      <a16:colId xmlns:a16="http://schemas.microsoft.com/office/drawing/2014/main" val="1128433579"/>
                    </a:ext>
                  </a:extLst>
                </a:gridCol>
                <a:gridCol w="328295">
                  <a:extLst>
                    <a:ext uri="{9D8B030D-6E8A-4147-A177-3AD203B41FA5}">
                      <a16:colId xmlns:a16="http://schemas.microsoft.com/office/drawing/2014/main" val="3068255869"/>
                    </a:ext>
                  </a:extLst>
                </a:gridCol>
              </a:tblGrid>
              <a:tr h="16319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 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3">
                  <a:txBody>
                    <a:bodyPr/>
                    <a:lstStyle/>
                    <a:p>
                      <a:pPr marL="71755" marR="71755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Control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vert="vert27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C9-glu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C9-gal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C9-lac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mPHN-glu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mPHN-gal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mPHN-lac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474065700"/>
                  </a:ext>
                </a:extLst>
              </a:tr>
              <a:tr h="49149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 N x CMC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5 </a:t>
                      </a:r>
                      <a:r>
                        <a:rPr lang="en-GB" sz="8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×</a:t>
                      </a: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 CAC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.0 </a:t>
                      </a:r>
                      <a:r>
                        <a:rPr lang="en-GB" sz="8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×</a:t>
                      </a: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  CAC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.5 </a:t>
                      </a:r>
                      <a:r>
                        <a:rPr lang="en-GB" sz="8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× </a:t>
                      </a: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CAC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5 </a:t>
                      </a:r>
                      <a:r>
                        <a:rPr lang="en-GB" sz="8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×</a:t>
                      </a: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 CAC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.0 </a:t>
                      </a:r>
                      <a:r>
                        <a:rPr lang="en-GB" sz="8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×</a:t>
                      </a: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  CAC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.5 </a:t>
                      </a:r>
                      <a:r>
                        <a:rPr lang="en-GB" sz="8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× </a:t>
                      </a: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CAC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5 </a:t>
                      </a:r>
                      <a:r>
                        <a:rPr lang="en-GB" sz="8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×</a:t>
                      </a: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 CAC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.0 </a:t>
                      </a:r>
                      <a:r>
                        <a:rPr lang="en-GB" sz="8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×</a:t>
                      </a: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  CAC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.5 </a:t>
                      </a:r>
                      <a:r>
                        <a:rPr lang="en-GB" sz="8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× </a:t>
                      </a: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CAC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5 </a:t>
                      </a:r>
                      <a:r>
                        <a:rPr lang="en-GB" sz="8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×</a:t>
                      </a: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 CAC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.0 </a:t>
                      </a:r>
                      <a:r>
                        <a:rPr lang="en-GB" sz="8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×</a:t>
                      </a: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  CAC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.5 </a:t>
                      </a:r>
                      <a:r>
                        <a:rPr lang="en-GB" sz="8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× </a:t>
                      </a: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CAC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5 </a:t>
                      </a:r>
                      <a:r>
                        <a:rPr lang="en-GB" sz="8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×</a:t>
                      </a: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 CAC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.0 </a:t>
                      </a:r>
                      <a:r>
                        <a:rPr lang="en-GB" sz="8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×</a:t>
                      </a: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  CAC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.5 </a:t>
                      </a:r>
                      <a:r>
                        <a:rPr lang="en-GB" sz="8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× </a:t>
                      </a: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CAC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5 </a:t>
                      </a:r>
                      <a:r>
                        <a:rPr lang="en-GB" sz="8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×</a:t>
                      </a: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 CAC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.0 </a:t>
                      </a:r>
                      <a:r>
                        <a:rPr lang="en-GB" sz="8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×</a:t>
                      </a: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  CAC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.5 </a:t>
                      </a:r>
                      <a:r>
                        <a:rPr lang="en-GB" sz="8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× </a:t>
                      </a: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CAC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27018406"/>
                  </a:ext>
                </a:extLst>
              </a:tr>
              <a:tr h="32702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time [min]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 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 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 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 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 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 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 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 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 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 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 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 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 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 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 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 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 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 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23877741"/>
                  </a:ext>
                </a:extLst>
              </a:tr>
              <a:tr h="16319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ABF8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1D58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1D58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1D58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1D58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1D58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1D58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5C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5C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5C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1D58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1D58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1D58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1D58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1D58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1D58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1D58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1D58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1D58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72210199"/>
                  </a:ext>
                </a:extLst>
              </a:tr>
              <a:tr h="16319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5DFE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1D58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1D58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1D58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1D58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1D58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1D58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5C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5C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5C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B8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1D58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1D58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1D58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1D58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1D58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1D58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1D58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1D58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27690206"/>
                  </a:ext>
                </a:extLst>
              </a:tr>
              <a:tr h="16319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5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5C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B8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B8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B8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1D58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B8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5C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5C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5C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B8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1D58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1D58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B8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1D58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1D58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B8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1D58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1D58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87545309"/>
                  </a:ext>
                </a:extLst>
              </a:tr>
              <a:tr h="16319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0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5C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B8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B8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B8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B8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B8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5C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B8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B8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5C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B8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B8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5C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B8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B8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97350946"/>
                  </a:ext>
                </a:extLst>
              </a:tr>
              <a:tr h="16319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60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5C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B8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B8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B8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B8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5C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5C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5C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5C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5C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5C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59070662"/>
                  </a:ext>
                </a:extLst>
              </a:tr>
              <a:tr h="16319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80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5C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5C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5C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5C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5C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5C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5C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5C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5C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5C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5C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93875229"/>
                  </a:ext>
                </a:extLst>
              </a:tr>
              <a:tr h="16319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440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5C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81356071"/>
                  </a:ext>
                </a:extLst>
              </a:tr>
            </a:tbl>
          </a:graphicData>
        </a:graphic>
      </p:graphicFrame>
      <p:graphicFrame>
        <p:nvGraphicFramePr>
          <p:cNvPr id="11" name="Table 1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49737182"/>
              </p:ext>
            </p:extLst>
          </p:nvPr>
        </p:nvGraphicFramePr>
        <p:xfrm>
          <a:off x="3348909" y="4059265"/>
          <a:ext cx="6657971" cy="2288540"/>
        </p:xfrm>
        <a:graphic>
          <a:graphicData uri="http://schemas.openxmlformats.org/drawingml/2006/table">
            <a:tbl>
              <a:tblPr firstRow="1" firstCol="1" bandRow="1"/>
              <a:tblGrid>
                <a:gridCol w="339712">
                  <a:extLst>
                    <a:ext uri="{9D8B030D-6E8A-4147-A177-3AD203B41FA5}">
                      <a16:colId xmlns:a16="http://schemas.microsoft.com/office/drawing/2014/main" val="215376508"/>
                    </a:ext>
                  </a:extLst>
                </a:gridCol>
                <a:gridCol w="372340">
                  <a:extLst>
                    <a:ext uri="{9D8B030D-6E8A-4147-A177-3AD203B41FA5}">
                      <a16:colId xmlns:a16="http://schemas.microsoft.com/office/drawing/2014/main" val="968053025"/>
                    </a:ext>
                  </a:extLst>
                </a:gridCol>
                <a:gridCol w="330756">
                  <a:extLst>
                    <a:ext uri="{9D8B030D-6E8A-4147-A177-3AD203B41FA5}">
                      <a16:colId xmlns:a16="http://schemas.microsoft.com/office/drawing/2014/main" val="697038830"/>
                    </a:ext>
                  </a:extLst>
                </a:gridCol>
                <a:gridCol w="331395">
                  <a:extLst>
                    <a:ext uri="{9D8B030D-6E8A-4147-A177-3AD203B41FA5}">
                      <a16:colId xmlns:a16="http://schemas.microsoft.com/office/drawing/2014/main" val="1695593550"/>
                    </a:ext>
                  </a:extLst>
                </a:gridCol>
                <a:gridCol w="331395">
                  <a:extLst>
                    <a:ext uri="{9D8B030D-6E8A-4147-A177-3AD203B41FA5}">
                      <a16:colId xmlns:a16="http://schemas.microsoft.com/office/drawing/2014/main" val="1674854957"/>
                    </a:ext>
                  </a:extLst>
                </a:gridCol>
                <a:gridCol w="331395">
                  <a:extLst>
                    <a:ext uri="{9D8B030D-6E8A-4147-A177-3AD203B41FA5}">
                      <a16:colId xmlns:a16="http://schemas.microsoft.com/office/drawing/2014/main" val="1095070039"/>
                    </a:ext>
                  </a:extLst>
                </a:gridCol>
                <a:gridCol w="332035">
                  <a:extLst>
                    <a:ext uri="{9D8B030D-6E8A-4147-A177-3AD203B41FA5}">
                      <a16:colId xmlns:a16="http://schemas.microsoft.com/office/drawing/2014/main" val="3925196373"/>
                    </a:ext>
                  </a:extLst>
                </a:gridCol>
                <a:gridCol w="331395">
                  <a:extLst>
                    <a:ext uri="{9D8B030D-6E8A-4147-A177-3AD203B41FA5}">
                      <a16:colId xmlns:a16="http://schemas.microsoft.com/office/drawing/2014/main" val="2467216355"/>
                    </a:ext>
                  </a:extLst>
                </a:gridCol>
                <a:gridCol w="331395">
                  <a:extLst>
                    <a:ext uri="{9D8B030D-6E8A-4147-A177-3AD203B41FA5}">
                      <a16:colId xmlns:a16="http://schemas.microsoft.com/office/drawing/2014/main" val="2370280957"/>
                    </a:ext>
                  </a:extLst>
                </a:gridCol>
                <a:gridCol w="331395">
                  <a:extLst>
                    <a:ext uri="{9D8B030D-6E8A-4147-A177-3AD203B41FA5}">
                      <a16:colId xmlns:a16="http://schemas.microsoft.com/office/drawing/2014/main" val="1990341402"/>
                    </a:ext>
                  </a:extLst>
                </a:gridCol>
                <a:gridCol w="332035">
                  <a:extLst>
                    <a:ext uri="{9D8B030D-6E8A-4147-A177-3AD203B41FA5}">
                      <a16:colId xmlns:a16="http://schemas.microsoft.com/office/drawing/2014/main" val="3729469616"/>
                    </a:ext>
                  </a:extLst>
                </a:gridCol>
                <a:gridCol w="331395">
                  <a:extLst>
                    <a:ext uri="{9D8B030D-6E8A-4147-A177-3AD203B41FA5}">
                      <a16:colId xmlns:a16="http://schemas.microsoft.com/office/drawing/2014/main" val="2186459914"/>
                    </a:ext>
                  </a:extLst>
                </a:gridCol>
                <a:gridCol w="331395">
                  <a:extLst>
                    <a:ext uri="{9D8B030D-6E8A-4147-A177-3AD203B41FA5}">
                      <a16:colId xmlns:a16="http://schemas.microsoft.com/office/drawing/2014/main" val="330647281"/>
                    </a:ext>
                  </a:extLst>
                </a:gridCol>
                <a:gridCol w="331395">
                  <a:extLst>
                    <a:ext uri="{9D8B030D-6E8A-4147-A177-3AD203B41FA5}">
                      <a16:colId xmlns:a16="http://schemas.microsoft.com/office/drawing/2014/main" val="4224687746"/>
                    </a:ext>
                  </a:extLst>
                </a:gridCol>
                <a:gridCol w="331395">
                  <a:extLst>
                    <a:ext uri="{9D8B030D-6E8A-4147-A177-3AD203B41FA5}">
                      <a16:colId xmlns:a16="http://schemas.microsoft.com/office/drawing/2014/main" val="804172255"/>
                    </a:ext>
                  </a:extLst>
                </a:gridCol>
                <a:gridCol w="332035">
                  <a:extLst>
                    <a:ext uri="{9D8B030D-6E8A-4147-A177-3AD203B41FA5}">
                      <a16:colId xmlns:a16="http://schemas.microsoft.com/office/drawing/2014/main" val="1403210825"/>
                    </a:ext>
                  </a:extLst>
                </a:gridCol>
                <a:gridCol w="331395">
                  <a:extLst>
                    <a:ext uri="{9D8B030D-6E8A-4147-A177-3AD203B41FA5}">
                      <a16:colId xmlns:a16="http://schemas.microsoft.com/office/drawing/2014/main" val="3180937747"/>
                    </a:ext>
                  </a:extLst>
                </a:gridCol>
                <a:gridCol w="331395">
                  <a:extLst>
                    <a:ext uri="{9D8B030D-6E8A-4147-A177-3AD203B41FA5}">
                      <a16:colId xmlns:a16="http://schemas.microsoft.com/office/drawing/2014/main" val="3075687656"/>
                    </a:ext>
                  </a:extLst>
                </a:gridCol>
                <a:gridCol w="331395">
                  <a:extLst>
                    <a:ext uri="{9D8B030D-6E8A-4147-A177-3AD203B41FA5}">
                      <a16:colId xmlns:a16="http://schemas.microsoft.com/office/drawing/2014/main" val="1614483259"/>
                    </a:ext>
                  </a:extLst>
                </a:gridCol>
                <a:gridCol w="310923">
                  <a:extLst>
                    <a:ext uri="{9D8B030D-6E8A-4147-A177-3AD203B41FA5}">
                      <a16:colId xmlns:a16="http://schemas.microsoft.com/office/drawing/2014/main" val="3855818255"/>
                    </a:ext>
                  </a:extLst>
                </a:gridCol>
              </a:tblGrid>
              <a:tr h="17589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 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3">
                  <a:txBody>
                    <a:bodyPr/>
                    <a:lstStyle/>
                    <a:p>
                      <a:pPr marL="71755" marR="71755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Control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vert="vert27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C9-glu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C9-gal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C9-lac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mPHN-glu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mPHN-gal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mPHN-lac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343626211"/>
                  </a:ext>
                </a:extLst>
              </a:tr>
              <a:tr h="52895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 N x CMC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5 </a:t>
                      </a:r>
                      <a:r>
                        <a:rPr lang="en-GB" sz="8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×</a:t>
                      </a: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 CAC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.0 </a:t>
                      </a:r>
                      <a:r>
                        <a:rPr lang="en-GB" sz="8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×</a:t>
                      </a: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  CAC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.5 </a:t>
                      </a:r>
                      <a:r>
                        <a:rPr lang="en-GB" sz="8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× </a:t>
                      </a: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CAC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5 </a:t>
                      </a:r>
                      <a:r>
                        <a:rPr lang="en-GB" sz="8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×</a:t>
                      </a: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 CAC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.0 </a:t>
                      </a:r>
                      <a:r>
                        <a:rPr lang="en-GB" sz="8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×</a:t>
                      </a: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  CAC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.5 </a:t>
                      </a:r>
                      <a:r>
                        <a:rPr lang="en-GB" sz="8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× </a:t>
                      </a: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CAC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5 </a:t>
                      </a:r>
                      <a:r>
                        <a:rPr lang="en-GB" sz="8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×</a:t>
                      </a: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 CAC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.0 </a:t>
                      </a:r>
                      <a:r>
                        <a:rPr lang="en-GB" sz="8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×</a:t>
                      </a: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  CAC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.5 </a:t>
                      </a:r>
                      <a:r>
                        <a:rPr lang="en-GB" sz="8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× </a:t>
                      </a: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CAC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5 </a:t>
                      </a:r>
                      <a:r>
                        <a:rPr lang="en-GB" sz="8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×</a:t>
                      </a: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 CAC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.0 </a:t>
                      </a:r>
                      <a:r>
                        <a:rPr lang="en-GB" sz="8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×</a:t>
                      </a: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  CAC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.5 </a:t>
                      </a:r>
                      <a:r>
                        <a:rPr lang="en-GB" sz="8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× </a:t>
                      </a: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CAC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5 </a:t>
                      </a:r>
                      <a:r>
                        <a:rPr lang="en-GB" sz="8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×</a:t>
                      </a: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 CAC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.0 </a:t>
                      </a:r>
                      <a:r>
                        <a:rPr lang="en-GB" sz="8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×</a:t>
                      </a: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  CAC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.5 </a:t>
                      </a:r>
                      <a:r>
                        <a:rPr lang="en-GB" sz="8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× </a:t>
                      </a: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CAC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5 </a:t>
                      </a:r>
                      <a:r>
                        <a:rPr lang="en-GB" sz="8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×</a:t>
                      </a: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 CAC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.0 </a:t>
                      </a:r>
                      <a:r>
                        <a:rPr lang="en-GB" sz="8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×</a:t>
                      </a: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  CAC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.5 </a:t>
                      </a:r>
                      <a:r>
                        <a:rPr lang="en-GB" sz="8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× </a:t>
                      </a: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CAC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28092209"/>
                  </a:ext>
                </a:extLst>
              </a:tr>
              <a:tr h="35242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time [min]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 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 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 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 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 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 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 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 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 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 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 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 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 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 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 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 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 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 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96317302"/>
                  </a:ext>
                </a:extLst>
              </a:tr>
              <a:tr h="17589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ABF8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4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3BE7B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4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3BE7B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4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3BE7B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4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3BE7B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4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3BE7B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4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3BE7B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1D58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4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3BE7B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1D58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1D58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1D58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1D58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1D58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4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3BE7B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4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3BE7B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1D58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4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3BE7B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4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3BE7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40663421"/>
                  </a:ext>
                </a:extLst>
              </a:tr>
              <a:tr h="17589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ABF8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1D58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1D58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1D58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4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3BE7B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4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3BE7B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1D58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1D58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1D58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1D58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B8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1D58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B8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1D58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1D58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4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3BE7B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1D58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1D58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4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3BE7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01017004"/>
                  </a:ext>
                </a:extLst>
              </a:tr>
              <a:tr h="17589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5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0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1D58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1D58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1D58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4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3BE7B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4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3BE7B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1D58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1D58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1D58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1D58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B8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1D58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B8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1D58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1D58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1D58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1D58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1D58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1D58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25468212"/>
                  </a:ext>
                </a:extLst>
              </a:tr>
              <a:tr h="17589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0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5DFE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1D58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1D58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1D58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1D58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1D58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1D58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B8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1D58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B8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B8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1D58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5C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1D58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1D58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1D58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1D58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1D58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1D58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29301773"/>
                  </a:ext>
                </a:extLst>
              </a:tr>
              <a:tr h="17589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60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1D58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1D58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1D58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1D58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1D58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1D58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B8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1D58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B8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B8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B8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5C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1D58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1D58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1D58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1D58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1D58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1D58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80893741"/>
                  </a:ext>
                </a:extLst>
              </a:tr>
              <a:tr h="17589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80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B8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B8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B8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5C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B8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B8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B8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B8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5C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B8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B8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5C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5C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5C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B8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5C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5C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B8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98260015"/>
                  </a:ext>
                </a:extLst>
              </a:tr>
              <a:tr h="17589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440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5C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B8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B8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5C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B8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B8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B8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B8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5C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5C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5C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5C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9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305" marR="2730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5C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45398599"/>
                  </a:ext>
                </a:extLst>
              </a:tr>
            </a:tbl>
          </a:graphicData>
        </a:graphic>
      </p:graphicFrame>
      <p:sp>
        <p:nvSpPr>
          <p:cNvPr id="12" name="TextBox 11"/>
          <p:cNvSpPr txBox="1"/>
          <p:nvPr/>
        </p:nvSpPr>
        <p:spPr>
          <a:xfrm>
            <a:off x="1230284" y="2597977"/>
            <a:ext cx="3048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)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3062848" y="1717980"/>
            <a:ext cx="3129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)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3092397" y="3920765"/>
            <a:ext cx="3129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)</a:t>
            </a:r>
          </a:p>
        </p:txBody>
      </p:sp>
    </p:spTree>
    <p:extLst>
      <p:ext uri="{BB962C8B-B14F-4D97-AF65-F5344CB8AC3E}">
        <p14:creationId xmlns:p14="http://schemas.microsoft.com/office/powerpoint/2010/main" val="221590959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</TotalTime>
  <Words>489</Words>
  <Application>Microsoft Macintosh PowerPoint</Application>
  <PresentationFormat>Panoramiczny</PresentationFormat>
  <Paragraphs>399</Paragraphs>
  <Slides>1</Slides>
  <Notes>0</Notes>
  <HiddenSlides>0</HiddenSlides>
  <MMClips>0</MMClips>
  <ScaleCrop>false</ScaleCrop>
  <HeadingPairs>
    <vt:vector size="6" baseType="variant">
      <vt:variant>
        <vt:lpstr>Używane czcionki</vt:lpstr>
      </vt:variant>
      <vt:variant>
        <vt:i4>4</vt:i4>
      </vt:variant>
      <vt:variant>
        <vt:lpstr>Motyw</vt:lpstr>
      </vt:variant>
      <vt:variant>
        <vt:i4>1</vt:i4>
      </vt:variant>
      <vt:variant>
        <vt:lpstr>Tytuły slajdów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rezentacja programu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asa</dc:creator>
  <cp:lastModifiedBy>Maciej Guzik</cp:lastModifiedBy>
  <cp:revision>3</cp:revision>
  <dcterms:created xsi:type="dcterms:W3CDTF">2022-11-28T01:32:10Z</dcterms:created>
  <dcterms:modified xsi:type="dcterms:W3CDTF">2023-01-17T08:02:58Z</dcterms:modified>
</cp:coreProperties>
</file>